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9" r:id="rId2"/>
    <p:sldId id="292" r:id="rId3"/>
    <p:sldId id="293" r:id="rId4"/>
    <p:sldId id="295" r:id="rId5"/>
  </p:sldIdLst>
  <p:sldSz cx="6858000" cy="9906000" type="A4"/>
  <p:notesSz cx="6886575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E13171E-1D0B-47B9-9301-DD7DC475A61B}" v="87" dt="2024-05-28T14:18:46.81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1590" y="-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673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4761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4854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4009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2289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6655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5527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455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2316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1448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5437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3C234-D167-4E06-ABBA-1899B07FAA27}" type="datetimeFigureOut">
              <a:rPr lang="it-IT" smtClean="0"/>
              <a:t>28/07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F4B99-4BC6-43B1-8FBD-28E80722C33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9097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4B0020EF-EDD2-704E-AB98-7A648A3E3F2C}"/>
              </a:ext>
            </a:extLst>
          </p:cNvPr>
          <p:cNvSpPr txBox="1"/>
          <p:nvPr/>
        </p:nvSpPr>
        <p:spPr>
          <a:xfrm>
            <a:off x="187325" y="146134"/>
            <a:ext cx="648335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sz="1200" b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Quantitative connection between METTL3 levels and EMT</a:t>
            </a:r>
          </a:p>
          <a:p>
            <a:pPr algn="just">
              <a:buNone/>
            </a:pP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expression levels of the indicated mRNAs in hepatocytes treated with TGF</a:t>
            </a:r>
            <a:r>
              <a:rPr lang="el-GR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 left untreated (TGF</a:t>
            </a:r>
            <a:r>
              <a:rPr lang="el-GR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NT respectively) analyzed by RT-qPCR. METTL3 silencing (shMETTL3) was induced with different concentrations of doxycycline. Left panels: cells treated with </a:t>
            </a:r>
            <a:r>
              <a:rPr lang="it-IT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0,5</a:t>
            </a:r>
            <a:r>
              <a:rPr lang="el-GR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/mL of doxycycline. Middle panels: cells treated with </a:t>
            </a:r>
            <a:r>
              <a:rPr lang="it-IT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l-GR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/mL of doxycycline. Right panels: cells treated with </a:t>
            </a:r>
            <a:r>
              <a:rPr lang="it-IT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l-GR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μ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/mL of doxycycline. </a:t>
            </a:r>
          </a:p>
          <a:p>
            <a:pPr algn="just"/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have been normalized with respect to 18S expression and are shown as the mean ± S.E.M. of three independent experiments. NT arbitrary value 1. Fold change between 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CTR+TGF</a:t>
            </a:r>
            <a:r>
              <a:rPr lang="el-GR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shMETTL3+TGF</a:t>
            </a:r>
            <a:r>
              <a:rPr lang="el-GR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b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 is reported on the graph. Data are considered statistically significant with p &lt; 0.05 (one-tailed paired t-test). p value: * &lt; 0.05, ** &lt;0.01, *** &lt;0.001.</a:t>
            </a:r>
            <a:endParaRPr lang="it-IT" sz="1200" kern="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buNone/>
            </a:pPr>
            <a:r>
              <a:rPr lang="en-US" sz="1200" b="1" kern="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it-IT" sz="1200" kern="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45261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F97B88D0-D76A-F30E-5B67-AE59E1684308}"/>
              </a:ext>
            </a:extLst>
          </p:cNvPr>
          <p:cNvSpPr txBox="1"/>
          <p:nvPr/>
        </p:nvSpPr>
        <p:spPr>
          <a:xfrm>
            <a:off x="0" y="127878"/>
            <a:ext cx="68580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sz="12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. HOTAIR overexpression rescues EMT in METTL3 knocked-down hepatocytes </a:t>
            </a:r>
          </a:p>
          <a:p>
            <a:pPr marL="228600" indent="-228600" algn="just">
              <a:buAutoNum type="alphaUcParenR"/>
            </a:pP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expression levels of the indicated mRNAs in hepatocytes expressing the indicated 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RNAs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the vector for HOTAIR ectopic expression or the empty vector as a control, analyzed by RT-qPCR. Data have been normalized with respect to L32 expression and are shown as the mean ± S.E.M. of three independent experiments. NT arbitrary value 1. Data are considered statistically significant with p &lt; 0.05 (two-tailed paired t-test). p value: * &lt; 0.05, ** &lt;0.01, *** &lt;0.001.</a:t>
            </a:r>
          </a:p>
          <a:p>
            <a:pPr marL="228600" indent="-228600" algn="just">
              <a:buAutoNum type="alphaUcParenR"/>
            </a:pP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RIP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qPCR analysis on HOTAIR SNAIL binding domain (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bid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murine non-tumorigenic </a:t>
            </a:r>
            <a:r>
              <a:rPr lang="en-US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patocytes as in A). Data are shown as the mean ± S.E.M. of three independent experiments and are represented as IP/IgG. HPRT1 was used as negative control. IgG arbitrary value= 1. Data are considered statistically significant with p &lt; 0.05 (one-tailed paired t-test). p value: * &lt; 0.05.</a:t>
            </a:r>
          </a:p>
          <a:p>
            <a:pPr marL="228600" indent="-228600" algn="just">
              <a:buFontTx/>
              <a:buAutoNum type="alphaUcParenR"/>
            </a:pP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expression levels of the indicated mRNAs in hepatocytes expressing the indicated 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RNAs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the vector for HOTAIR ectopic expression or the empty vector as a control, analyzed by RT-qPCR. Data have been normalized with respect to L32 expression and are shown as the mean ± S.E.M. of three independent experiments. NT arbitrary value 1. Data are considered statistically significant with p &lt; 0.05 (two-tailed paired t-test). p value: * &lt; 0.05.</a:t>
            </a:r>
          </a:p>
          <a:p>
            <a:pPr marL="228600" indent="-228600" algn="just">
              <a:buAutoNum type="alphaUcParenR"/>
            </a:pPr>
            <a:endParaRPr lang="en-US" sz="1200" b="1" kern="0" dirty="0">
              <a:solidFill>
                <a:srgbClr val="FF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buNone/>
            </a:pPr>
            <a:r>
              <a:rPr lang="en-US" sz="1200" b="1" kern="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65725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B6CA920-221A-A3E7-014A-3631A1B54D24}"/>
              </a:ext>
            </a:extLst>
          </p:cNvPr>
          <p:cNvSpPr txBox="1"/>
          <p:nvPr/>
        </p:nvSpPr>
        <p:spPr>
          <a:xfrm>
            <a:off x="0" y="127878"/>
            <a:ext cx="6858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sz="12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. METTL3 overexpression does not promote EMT in absence of HOTAIR</a:t>
            </a:r>
          </a:p>
          <a:p>
            <a:pPr algn="just">
              <a:buNone/>
            </a:pPr>
            <a:endParaRPr lang="en-US" sz="1200" b="1" kern="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buNone/>
            </a:pP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expression levels of the indicated mRNAs in hepatocytes expressing the vector for METTL3 ectopic expression or the empty vector as a control, analyzed by RT-qPCR. Data have been normalized with respect to 18S expression and are shown as the mean ± S.E.M. of three independent experiments. NT arbitrary value 1. Data are considered statistically significant with p &lt; 0.05 (two-tailed paired t-test). p value: ** &lt;0.01.</a:t>
            </a:r>
          </a:p>
          <a:p>
            <a:pPr marL="228600" indent="-228600" algn="just">
              <a:buAutoNum type="alphaUcParenR"/>
            </a:pPr>
            <a:endParaRPr lang="en-US" sz="1200" kern="0" dirty="0">
              <a:solidFill>
                <a:srgbClr val="FF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 algn="just">
              <a:buAutoNum type="alphaUcParenR"/>
            </a:pPr>
            <a:endParaRPr lang="en-US" sz="1200" b="1" kern="0" dirty="0">
              <a:solidFill>
                <a:srgbClr val="FF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buNone/>
            </a:pPr>
            <a:r>
              <a:rPr lang="en-US" sz="1200" b="1" kern="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93422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B178C79C-85B2-25D3-BFC7-3213A4B7B528}"/>
              </a:ext>
            </a:extLst>
          </p:cNvPr>
          <p:cNvSpPr txBox="1"/>
          <p:nvPr/>
        </p:nvSpPr>
        <p:spPr>
          <a:xfrm>
            <a:off x="0" y="127878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sz="12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. METTL3 silencing impairs cell migration in absence of cell proliferation</a:t>
            </a:r>
          </a:p>
          <a:p>
            <a:pPr algn="just">
              <a:buNone/>
            </a:pP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Top) Immunofluorescence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tection of KI67 in proliferating cells. (Bottom) 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fluorescence detection of KI67 in hepatocytes undergoing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F</a:t>
            </a:r>
            <a:r>
              <a:rPr kumimoji="0" lang="el-GR" sz="12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uced EMT and in human cancer cells (SW480), both </a:t>
            </a:r>
            <a:r>
              <a:rPr kumimoji="0" lang="en-US" sz="1200" b="0" i="0" u="none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CTR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shMETTL3 under serum starvation (48h). DNA-DAPI (blue), KI67 (red).</a:t>
            </a:r>
            <a:endParaRPr lang="it-IT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8400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Tema 2022">
  <a:themeElements>
    <a:clrScheme name="Office 2013 - Tema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Tema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Tema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5708</TotalTime>
  <Words>604</Words>
  <Application>Microsoft Office PowerPoint</Application>
  <PresentationFormat>A4 (21x29,7 cm)</PresentationFormat>
  <Paragraphs>18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2013 - Tema 2022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brina Garbo</dc:creator>
  <cp:lastModifiedBy>Sabrina Garbo</cp:lastModifiedBy>
  <cp:revision>104</cp:revision>
  <cp:lastPrinted>2025-07-24T13:48:09Z</cp:lastPrinted>
  <dcterms:created xsi:type="dcterms:W3CDTF">2023-04-26T08:43:27Z</dcterms:created>
  <dcterms:modified xsi:type="dcterms:W3CDTF">2025-07-28T16:18:21Z</dcterms:modified>
</cp:coreProperties>
</file>